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>
        <p:scale>
          <a:sx n="80" d="100"/>
          <a:sy n="80" d="100"/>
        </p:scale>
        <p:origin x="834" y="-11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08691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41054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64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37772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04491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46511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6280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3707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8769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3619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1842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86176-FC33-4E3B-BB30-6B9D07DB3D21}" type="datetimeFigureOut">
              <a:rPr lang="en-AU" smtClean="0"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97452-844D-40FA-B41A-023794AA239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02306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4216349"/>
              </p:ext>
            </p:extLst>
          </p:nvPr>
        </p:nvGraphicFramePr>
        <p:xfrm>
          <a:off x="726330" y="1192801"/>
          <a:ext cx="5039470" cy="30648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CorelDRAW" r:id="rId3" imgW="3301635" imgH="2008558" progId="CorelDraw.Graphic.17">
                  <p:embed/>
                </p:oleObj>
              </mc:Choice>
              <mc:Fallback>
                <p:oleObj name="CorelDRAW" r:id="rId3" imgW="3301635" imgH="2008558" progId="CorelDraw.Graphic.17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26330" y="1192801"/>
                        <a:ext cx="5039470" cy="30648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1773821" y="4257669"/>
            <a:ext cx="340760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4 Fig. Ribbon diagrams representing the highest resolved crystal structure of the p66/p51 heterodimer (PDB B ID: 4G1Q)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3292175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</TotalTime>
  <Words>2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CorelDRAW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 Way</dc:creator>
  <cp:lastModifiedBy>B Way</cp:lastModifiedBy>
  <cp:revision>5</cp:revision>
  <dcterms:created xsi:type="dcterms:W3CDTF">2015-11-04T19:56:04Z</dcterms:created>
  <dcterms:modified xsi:type="dcterms:W3CDTF">2015-11-04T23:52:29Z</dcterms:modified>
</cp:coreProperties>
</file>